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691813" cy="755967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17E11-8E9F-4655-8BE8-347C706C12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35120" y="2012760"/>
            <a:ext cx="922176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35120" y="4518000"/>
            <a:ext cx="922176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F00FD-7527-4881-A403-BC8504E01F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35120" y="201276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460480" y="201276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35120" y="451800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460480" y="451800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EDB22-430F-4E0E-BD30-383C3335D3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35120" y="2012760"/>
            <a:ext cx="296928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53080" y="2012760"/>
            <a:ext cx="296928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971400" y="2012760"/>
            <a:ext cx="296928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35120" y="4518000"/>
            <a:ext cx="296928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53080" y="4518000"/>
            <a:ext cx="296928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971400" y="4518000"/>
            <a:ext cx="296928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8842A-3A3D-48C6-9963-066E0C085A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35120" y="2012760"/>
            <a:ext cx="9221760" cy="479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76"/>
              </a:spcBef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B8114-5AEC-4256-83FE-75B439A5F2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35120" y="2012760"/>
            <a:ext cx="9221760" cy="47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F98E5-963C-47F1-A9C4-61CDD55EFF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35120" y="2012760"/>
            <a:ext cx="4500000" cy="47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460480" y="2012760"/>
            <a:ext cx="4500000" cy="47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990BF-1CC1-49D8-8E00-595EF24F69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D0D62-DB88-49F7-8BE9-C485926F9C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35120" y="402840"/>
            <a:ext cx="9221760" cy="6771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76"/>
              </a:spcBef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CD8CE-182E-40FA-881D-4306E577F5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35120" y="201276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460480" y="2012760"/>
            <a:ext cx="4500000" cy="47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35120" y="451800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A8526-4920-48B9-A9E1-90D236C2F1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35120" y="2012760"/>
            <a:ext cx="4500000" cy="47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460480" y="201276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460480" y="451800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AAFEC1-E4CF-4C57-9448-48006D985C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35120" y="201276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460480" y="2012760"/>
            <a:ext cx="450000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35120" y="4518000"/>
            <a:ext cx="9221760" cy="228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76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A4F1B3-EFF9-4054-BC73-39A0FA3DE5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35120" y="402840"/>
            <a:ext cx="9221760" cy="146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35120" y="2012760"/>
            <a:ext cx="9221760" cy="4795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00160" indent="-200160">
              <a:lnSpc>
                <a:spcPct val="90000"/>
              </a:lnSpc>
              <a:spcBef>
                <a:spcPts val="876"/>
              </a:spcBef>
              <a:buClr>
                <a:srgbClr val="000000"/>
              </a:buClr>
              <a:buFont typeface="Arial"/>
              <a:buChar char="•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600120" indent="-200160">
              <a:lnSpc>
                <a:spcPct val="90000"/>
              </a:lnSpc>
              <a:spcBef>
                <a:spcPts val="876"/>
              </a:spcBef>
              <a:buClr>
                <a:srgbClr val="000000"/>
              </a:buClr>
              <a:buFont typeface="Arial"/>
              <a:buChar char="•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2" marL="1001880" indent="-200160">
              <a:lnSpc>
                <a:spcPct val="90000"/>
              </a:lnSpc>
              <a:spcBef>
                <a:spcPts val="876"/>
              </a:spcBef>
              <a:buClr>
                <a:srgbClr val="000000"/>
              </a:buClr>
              <a:buFont typeface="Arial"/>
              <a:buChar char="•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3" marL="1403280" indent="-199800">
              <a:lnSpc>
                <a:spcPct val="90000"/>
              </a:lnSpc>
              <a:spcBef>
                <a:spcPts val="876"/>
              </a:spcBef>
              <a:buClr>
                <a:srgbClr val="000000"/>
              </a:buClr>
              <a:buFont typeface="Arial"/>
              <a:buChar char="•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4" marL="1803240" indent="-199800">
              <a:lnSpc>
                <a:spcPct val="90000"/>
              </a:lnSpc>
              <a:spcBef>
                <a:spcPts val="876"/>
              </a:spcBef>
              <a:buClr>
                <a:srgbClr val="000000"/>
              </a:buClr>
              <a:buFont typeface="Arial"/>
              <a:buChar char="•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5" marL="1803240" indent="-199800">
              <a:lnSpc>
                <a:spcPct val="90000"/>
              </a:lnSpc>
              <a:spcBef>
                <a:spcPts val="876"/>
              </a:spcBef>
              <a:buClr>
                <a:srgbClr val="000000"/>
              </a:buClr>
              <a:buFont typeface="Arial"/>
              <a:buChar char="•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6" marL="1803240" indent="-199800">
              <a:lnSpc>
                <a:spcPct val="90000"/>
              </a:lnSpc>
              <a:spcBef>
                <a:spcPts val="876"/>
              </a:spcBef>
              <a:buClr>
                <a:srgbClr val="000000"/>
              </a:buClr>
              <a:buFont typeface="Arial"/>
              <a:buChar char="•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35120" y="7007040"/>
            <a:ext cx="2404800" cy="401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0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541320" y="7007040"/>
            <a:ext cx="3608280" cy="401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551360" y="7007040"/>
            <a:ext cx="2405160" cy="401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AD8247-E590-47C9-A8C9-715123AF9E5E}" type="slidenum">
              <a:rPr b="0" lang="pt-BR" sz="10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m 6" descr=""/>
          <p:cNvPicPr/>
          <p:nvPr/>
        </p:nvPicPr>
        <p:blipFill>
          <a:blip r:embed="rId1"/>
          <a:stretch/>
        </p:blipFill>
        <p:spPr>
          <a:xfrm>
            <a:off x="777960" y="125280"/>
            <a:ext cx="9136080" cy="5916600"/>
          </a:xfrm>
          <a:prstGeom prst="rect">
            <a:avLst/>
          </a:prstGeom>
          <a:ln w="0">
            <a:noFill/>
          </a:ln>
        </p:spPr>
      </p:pic>
      <p:sp>
        <p:nvSpPr>
          <p:cNvPr id="42" name="Retângulo 1"/>
          <p:cNvSpPr/>
          <p:nvPr/>
        </p:nvSpPr>
        <p:spPr>
          <a:xfrm>
            <a:off x="468360" y="6041880"/>
            <a:ext cx="100584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elations outcom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BF </a:t>
            </a:r>
            <a:r>
              <a:rPr b="0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ody fat percentage, </a:t>
            </a:r>
            <a:r>
              <a:rPr b="0" i="1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MM </a:t>
            </a:r>
            <a:r>
              <a:rPr b="0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ody skeletal muscle percentage, </a:t>
            </a:r>
            <a:r>
              <a:rPr b="0" i="1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VDRisk30y</a:t>
            </a:r>
            <a:r>
              <a:rPr b="0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30 year CVD risk, </a:t>
            </a:r>
            <a:r>
              <a:rPr b="0" i="1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MI</a:t>
            </a:r>
            <a:r>
              <a:rPr b="0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at mass index, </a:t>
            </a:r>
            <a:r>
              <a:rPr b="0" i="1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M</a:t>
            </a:r>
            <a:r>
              <a:rPr b="0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scle mass, </a:t>
            </a:r>
            <a:r>
              <a:rPr b="0" i="1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MIheight</a:t>
            </a:r>
            <a:r>
              <a:rPr b="0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keletal muscle index, </a:t>
            </a:r>
            <a:r>
              <a:rPr b="0" i="1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C</a:t>
            </a:r>
            <a:r>
              <a:rPr b="0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aist circumferenc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0-16T20:00:30Z</dcterms:created>
  <dc:creator>Leandro Manfredi</dc:creator>
  <dc:description/>
  <dc:language>en-US</dc:language>
  <cp:lastModifiedBy>Hugo</cp:lastModifiedBy>
  <dcterms:modified xsi:type="dcterms:W3CDTF">2020-12-24T14:52:26Z</dcterms:modified>
  <cp:revision>3</cp:revision>
  <dc:subject/>
  <dc:title>Apresentação do PowerPoint</dc:title>
</cp:coreProperties>
</file>